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</p:sldIdLst>
  <p:sldSz cx="9144000" cy="12599988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6" d="100"/>
          <a:sy n="46" d="100"/>
        </p:scale>
        <p:origin x="-2400" y="-86"/>
      </p:cViewPr>
      <p:guideLst>
        <p:guide orient="horz" pos="3968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062083"/>
            <a:ext cx="7772400" cy="438666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6617911"/>
            <a:ext cx="6858000" cy="3042080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2/12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335033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2/12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165716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670833"/>
            <a:ext cx="1971675" cy="10677907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670833"/>
            <a:ext cx="5800725" cy="10677907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2/12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905709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2/12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26505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141251"/>
            <a:ext cx="7886700" cy="5241244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8432079"/>
            <a:ext cx="7886700" cy="2756246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2/12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60657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354163"/>
            <a:ext cx="3886200" cy="7994577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354163"/>
            <a:ext cx="3886200" cy="7994577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2/12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477723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70836"/>
            <a:ext cx="7886700" cy="243541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3088748"/>
            <a:ext cx="3868340" cy="151374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4602496"/>
            <a:ext cx="3868340" cy="676957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3088748"/>
            <a:ext cx="3887391" cy="151374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4602496"/>
            <a:ext cx="3887391" cy="676957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2/12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20887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2/12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110048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2/12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974343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39999"/>
            <a:ext cx="2949178" cy="2939997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814168"/>
            <a:ext cx="4629150" cy="895415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779996"/>
            <a:ext cx="2949178" cy="7002911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2/12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372307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39999"/>
            <a:ext cx="2949178" cy="2939997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814168"/>
            <a:ext cx="4629150" cy="8954158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779996"/>
            <a:ext cx="2949178" cy="7002911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4BC7-51BA-4B4C-B859-422EAE3CEDCB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2/12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74D3D-2047-4C26-8EF4-F244FEF73202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73752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670836"/>
            <a:ext cx="7886700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354163"/>
            <a:ext cx="7886700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1678325"/>
            <a:ext cx="2057400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1439898"/>
            <a:fld id="{F07A4BC7-51BA-4B4C-B859-422EAE3CEDCB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 defTabSz="1439898"/>
              <a:t>02/12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1678325"/>
            <a:ext cx="3086100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1439898"/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1678325"/>
            <a:ext cx="2057400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1439898"/>
            <a:fld id="{55F74D3D-2047-4C26-8EF4-F244FEF73202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 defTabSz="1439898"/>
              <a:t>‹N°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569338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117879" y="304014"/>
            <a:ext cx="89211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439898"/>
            <a:r>
              <a:rPr lang="it-IT" b="1" dirty="0" smtClean="0">
                <a:solidFill>
                  <a:prstClr val="black"/>
                </a:solidFill>
              </a:rPr>
              <a:t>Figure S2</a:t>
            </a:r>
            <a:r>
              <a:rPr lang="it-IT" b="1" dirty="0">
                <a:solidFill>
                  <a:prstClr val="black"/>
                </a:solidFill>
              </a:rPr>
              <a:t>. </a:t>
            </a:r>
            <a:r>
              <a:rPr lang="it-IT" b="1" dirty="0" err="1">
                <a:solidFill>
                  <a:prstClr val="black"/>
                </a:solidFill>
              </a:rPr>
              <a:t>Overall</a:t>
            </a:r>
            <a:r>
              <a:rPr lang="it-IT" b="1" dirty="0">
                <a:solidFill>
                  <a:prstClr val="black"/>
                </a:solidFill>
              </a:rPr>
              <a:t> </a:t>
            </a:r>
            <a:r>
              <a:rPr lang="it-IT" b="1" dirty="0" err="1">
                <a:solidFill>
                  <a:prstClr val="black"/>
                </a:solidFill>
              </a:rPr>
              <a:t>survival</a:t>
            </a:r>
            <a:r>
              <a:rPr lang="it-IT" b="1" dirty="0">
                <a:solidFill>
                  <a:prstClr val="black"/>
                </a:solidFill>
              </a:rPr>
              <a:t> </a:t>
            </a:r>
            <a:r>
              <a:rPr lang="it-IT" b="1" dirty="0" err="1">
                <a:solidFill>
                  <a:prstClr val="black"/>
                </a:solidFill>
              </a:rPr>
              <a:t>according</a:t>
            </a:r>
            <a:r>
              <a:rPr lang="it-IT" b="1" dirty="0">
                <a:solidFill>
                  <a:prstClr val="black"/>
                </a:solidFill>
              </a:rPr>
              <a:t> to PD-L1 </a:t>
            </a:r>
            <a:r>
              <a:rPr lang="it-IT" b="1" dirty="0" err="1">
                <a:solidFill>
                  <a:prstClr val="black"/>
                </a:solidFill>
              </a:rPr>
              <a:t>expression</a:t>
            </a:r>
            <a:r>
              <a:rPr lang="it-IT" b="1" dirty="0">
                <a:solidFill>
                  <a:prstClr val="black"/>
                </a:solidFill>
              </a:rPr>
              <a:t> in HER2+ </a:t>
            </a:r>
            <a:r>
              <a:rPr lang="it-IT" b="1" dirty="0" err="1">
                <a:solidFill>
                  <a:prstClr val="black"/>
                </a:solidFill>
              </a:rPr>
              <a:t>patients</a:t>
            </a:r>
            <a:r>
              <a:rPr lang="it-IT" b="1" dirty="0">
                <a:solidFill>
                  <a:prstClr val="black"/>
                </a:solidFill>
              </a:rPr>
              <a:t> (2A) and TN </a:t>
            </a:r>
            <a:r>
              <a:rPr lang="it-IT" b="1" dirty="0" err="1">
                <a:solidFill>
                  <a:prstClr val="black"/>
                </a:solidFill>
              </a:rPr>
              <a:t>patients</a:t>
            </a:r>
            <a:r>
              <a:rPr lang="it-IT" b="1" dirty="0">
                <a:solidFill>
                  <a:prstClr val="black"/>
                </a:solidFill>
              </a:rPr>
              <a:t> (2B). </a:t>
            </a:r>
          </a:p>
        </p:txBody>
      </p:sp>
      <p:graphicFrame>
        <p:nvGraphicFramePr>
          <p:cNvPr id="22" name="Tabella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06979548"/>
              </p:ext>
            </p:extLst>
          </p:nvPr>
        </p:nvGraphicFramePr>
        <p:xfrm>
          <a:off x="475263" y="5365056"/>
          <a:ext cx="8466451" cy="115524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2607321"/>
                <a:gridCol w="938690"/>
                <a:gridCol w="2889417"/>
                <a:gridCol w="2031023"/>
              </a:tblGrid>
              <a:tr h="382541">
                <a:tc>
                  <a:txBody>
                    <a:bodyPr/>
                    <a:lstStyle/>
                    <a:p>
                      <a:pPr algn="ctr"/>
                      <a:r>
                        <a:rPr lang="it-IT" sz="1700" dirty="0" smtClean="0"/>
                        <a:t>PDL1</a:t>
                      </a:r>
                      <a:r>
                        <a:rPr lang="it-IT" sz="1700" baseline="0" dirty="0" smtClean="0"/>
                        <a:t> </a:t>
                      </a:r>
                      <a:r>
                        <a:rPr lang="it-IT" sz="1700" baseline="0" dirty="0" err="1" smtClean="0"/>
                        <a:t>cut</a:t>
                      </a:r>
                      <a:r>
                        <a:rPr lang="it-IT" sz="1700" baseline="0" dirty="0" smtClean="0"/>
                        <a:t>-off %</a:t>
                      </a:r>
                      <a:endParaRPr lang="it-IT" sz="1700" b="1" dirty="0">
                        <a:solidFill>
                          <a:schemeClr val="tx1"/>
                        </a:solidFill>
                      </a:endParaRPr>
                    </a:p>
                  </a:txBody>
                  <a:tcPr marL="126000" marR="126000" marT="63000" marB="6300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700" dirty="0" smtClean="0"/>
                        <a:t>n</a:t>
                      </a:r>
                      <a:endParaRPr lang="it-IT" sz="1700" b="1" dirty="0">
                        <a:solidFill>
                          <a:schemeClr val="tx1"/>
                        </a:solidFill>
                      </a:endParaRPr>
                    </a:p>
                  </a:txBody>
                  <a:tcPr marL="126000" marR="126000" marT="63000" marB="63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700" dirty="0" err="1" smtClean="0"/>
                        <a:t>Median</a:t>
                      </a:r>
                      <a:r>
                        <a:rPr lang="it-IT" sz="1700" dirty="0" smtClean="0"/>
                        <a:t> OS</a:t>
                      </a:r>
                      <a:endParaRPr lang="it-IT" sz="1700" b="1" dirty="0">
                        <a:solidFill>
                          <a:schemeClr val="tx1"/>
                        </a:solidFill>
                      </a:endParaRPr>
                    </a:p>
                  </a:txBody>
                  <a:tcPr marL="126000" marR="126000" marT="63000" marB="63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700" dirty="0" smtClean="0"/>
                        <a:t>95% CI</a:t>
                      </a:r>
                      <a:endParaRPr lang="it-IT" sz="1700" b="1" dirty="0">
                        <a:solidFill>
                          <a:schemeClr val="tx1"/>
                        </a:solidFill>
                      </a:endParaRPr>
                    </a:p>
                  </a:txBody>
                  <a:tcPr marL="126000" marR="126000" marT="63000" marB="63000" anchor="ctr"/>
                </a:tc>
              </a:tr>
              <a:tr h="382541">
                <a:tc>
                  <a:txBody>
                    <a:bodyPr/>
                    <a:lstStyle/>
                    <a:p>
                      <a:pPr algn="ctr"/>
                      <a:r>
                        <a:rPr lang="it-IT" sz="1700" dirty="0" smtClean="0"/>
                        <a:t>≤ 5</a:t>
                      </a:r>
                      <a:endParaRPr lang="it-IT" sz="1700" b="1" dirty="0">
                        <a:solidFill>
                          <a:schemeClr val="tx1"/>
                        </a:solidFill>
                      </a:endParaRPr>
                    </a:p>
                  </a:txBody>
                  <a:tcPr marL="126000" marR="126000" marT="63000" marB="6300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700" dirty="0" smtClean="0"/>
                        <a:t>15</a:t>
                      </a:r>
                      <a:endParaRPr lang="it-IT" sz="1700" dirty="0"/>
                    </a:p>
                  </a:txBody>
                  <a:tcPr marL="126000" marR="126000" marT="63000" marB="63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700" dirty="0" smtClean="0"/>
                        <a:t>39,42 m</a:t>
                      </a:r>
                      <a:endParaRPr lang="it-IT" sz="1700" dirty="0"/>
                    </a:p>
                  </a:txBody>
                  <a:tcPr marL="126000" marR="126000" marT="63000" marB="63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700" dirty="0" smtClean="0"/>
                        <a:t>23,81-55,02</a:t>
                      </a:r>
                      <a:endParaRPr lang="it-IT" sz="1700" dirty="0"/>
                    </a:p>
                  </a:txBody>
                  <a:tcPr marL="126000" marR="126000" marT="63000" marB="63000" anchor="ctr"/>
                </a:tc>
              </a:tr>
              <a:tr h="38254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700" dirty="0" smtClean="0"/>
                        <a:t>&gt; 5</a:t>
                      </a:r>
                      <a:endParaRPr lang="it-IT" sz="1700" b="1" dirty="0" smtClean="0"/>
                    </a:p>
                  </a:txBody>
                  <a:tcPr marL="126000" marR="126000" marT="63000" marB="6300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700" dirty="0" smtClean="0"/>
                        <a:t>20</a:t>
                      </a:r>
                      <a:endParaRPr lang="it-IT" sz="1700" dirty="0"/>
                    </a:p>
                  </a:txBody>
                  <a:tcPr marL="126000" marR="126000" marT="63000" marB="6300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700" dirty="0" smtClean="0"/>
                        <a:t>46,49 m</a:t>
                      </a:r>
                      <a:endParaRPr lang="it-IT" sz="1700" dirty="0"/>
                    </a:p>
                  </a:txBody>
                  <a:tcPr marL="126000" marR="126000" marT="63000" marB="63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700" dirty="0" smtClean="0"/>
                        <a:t>34,30-58,68</a:t>
                      </a:r>
                      <a:endParaRPr lang="it-IT" sz="1700" dirty="0"/>
                    </a:p>
                  </a:txBody>
                  <a:tcPr marL="126000" marR="126000" marT="63000" marB="63000" anchor="ctr"/>
                </a:tc>
              </a:tr>
            </a:tbl>
          </a:graphicData>
        </a:graphic>
      </p:graphicFrame>
      <p:grpSp>
        <p:nvGrpSpPr>
          <p:cNvPr id="6" name="Gruppo 5"/>
          <p:cNvGrpSpPr/>
          <p:nvPr/>
        </p:nvGrpSpPr>
        <p:grpSpPr>
          <a:xfrm>
            <a:off x="312064" y="1794047"/>
            <a:ext cx="7355753" cy="3418267"/>
            <a:chOff x="1753020" y="977709"/>
            <a:chExt cx="4626576" cy="4048828"/>
          </a:xfrm>
        </p:grpSpPr>
        <p:grpSp>
          <p:nvGrpSpPr>
            <p:cNvPr id="3" name="Gruppo 2"/>
            <p:cNvGrpSpPr/>
            <p:nvPr/>
          </p:nvGrpSpPr>
          <p:grpSpPr>
            <a:xfrm>
              <a:off x="1753020" y="977709"/>
              <a:ext cx="4514527" cy="4048828"/>
              <a:chOff x="1753020" y="977709"/>
              <a:chExt cx="4514527" cy="4048828"/>
            </a:xfrm>
          </p:grpSpPr>
          <p:pic>
            <p:nvPicPr>
              <p:cNvPr id="2052" name="Picture 4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27" t="13104" r="26634" b="11777"/>
              <a:stretch/>
            </p:blipFill>
            <p:spPr bwMode="auto">
              <a:xfrm>
                <a:off x="2374294" y="977709"/>
                <a:ext cx="3893253" cy="34725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5" name="Gruppo 4"/>
              <p:cNvGrpSpPr/>
              <p:nvPr/>
            </p:nvGrpSpPr>
            <p:grpSpPr>
              <a:xfrm>
                <a:off x="1753020" y="1029838"/>
                <a:ext cx="3802879" cy="3996699"/>
                <a:chOff x="700300" y="1534966"/>
                <a:chExt cx="5810835" cy="6106994"/>
              </a:xfrm>
            </p:grpSpPr>
            <p:sp>
              <p:nvSpPr>
                <p:cNvPr id="7" name="CasellaDiTesto 6"/>
                <p:cNvSpPr txBox="1"/>
                <p:nvPr/>
              </p:nvSpPr>
              <p:spPr>
                <a:xfrm>
                  <a:off x="1608241" y="6350871"/>
                  <a:ext cx="360056" cy="38968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defTabSz="1439898"/>
                  <a:r>
                    <a:rPr lang="it-IT" sz="1683" b="1" dirty="0">
                      <a:solidFill>
                        <a:prstClr val="black"/>
                      </a:solidFill>
                    </a:rPr>
                    <a:t>0</a:t>
                  </a:r>
                </a:p>
              </p:txBody>
            </p:sp>
            <p:sp>
              <p:nvSpPr>
                <p:cNvPr id="8" name="CasellaDiTesto 7"/>
                <p:cNvSpPr txBox="1"/>
                <p:nvPr/>
              </p:nvSpPr>
              <p:spPr>
                <a:xfrm>
                  <a:off x="1454791" y="5380491"/>
                  <a:ext cx="513506" cy="38968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defTabSz="1439898"/>
                  <a:r>
                    <a:rPr lang="it-IT" sz="1683" b="1" dirty="0">
                      <a:solidFill>
                        <a:prstClr val="black"/>
                      </a:solidFill>
                    </a:rPr>
                    <a:t>20</a:t>
                  </a:r>
                </a:p>
              </p:txBody>
            </p:sp>
            <p:sp>
              <p:nvSpPr>
                <p:cNvPr id="9" name="CasellaDiTesto 8"/>
                <p:cNvSpPr txBox="1"/>
                <p:nvPr/>
              </p:nvSpPr>
              <p:spPr>
                <a:xfrm>
                  <a:off x="1454791" y="4406814"/>
                  <a:ext cx="513506" cy="38968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defTabSz="1439898"/>
                  <a:r>
                    <a:rPr lang="it-IT" sz="1683" b="1" dirty="0">
                      <a:solidFill>
                        <a:prstClr val="black"/>
                      </a:solidFill>
                    </a:rPr>
                    <a:t>40</a:t>
                  </a:r>
                </a:p>
              </p:txBody>
            </p:sp>
            <p:sp>
              <p:nvSpPr>
                <p:cNvPr id="10" name="CasellaDiTesto 9"/>
                <p:cNvSpPr txBox="1"/>
                <p:nvPr/>
              </p:nvSpPr>
              <p:spPr>
                <a:xfrm>
                  <a:off x="1454791" y="3462872"/>
                  <a:ext cx="513506" cy="38968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defTabSz="1439898"/>
                  <a:r>
                    <a:rPr lang="it-IT" sz="1683" b="1" dirty="0">
                      <a:solidFill>
                        <a:prstClr val="black"/>
                      </a:solidFill>
                    </a:rPr>
                    <a:t>60</a:t>
                  </a:r>
                </a:p>
              </p:txBody>
            </p:sp>
            <p:sp>
              <p:nvSpPr>
                <p:cNvPr id="11" name="CasellaDiTesto 10"/>
                <p:cNvSpPr txBox="1"/>
                <p:nvPr/>
              </p:nvSpPr>
              <p:spPr>
                <a:xfrm>
                  <a:off x="1454791" y="2511129"/>
                  <a:ext cx="513506" cy="38968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defTabSz="1439898"/>
                  <a:r>
                    <a:rPr lang="it-IT" sz="1683" b="1" dirty="0">
                      <a:solidFill>
                        <a:prstClr val="black"/>
                      </a:solidFill>
                    </a:rPr>
                    <a:t>80</a:t>
                  </a:r>
                </a:p>
              </p:txBody>
            </p:sp>
            <p:sp>
              <p:nvSpPr>
                <p:cNvPr id="12" name="CasellaDiTesto 11"/>
                <p:cNvSpPr txBox="1"/>
                <p:nvPr/>
              </p:nvSpPr>
              <p:spPr>
                <a:xfrm>
                  <a:off x="1347333" y="1534966"/>
                  <a:ext cx="623425" cy="38968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defTabSz="1439898"/>
                  <a:r>
                    <a:rPr lang="it-IT" sz="1683" b="1" dirty="0">
                      <a:solidFill>
                        <a:prstClr val="black"/>
                      </a:solidFill>
                    </a:rPr>
                    <a:t>100</a:t>
                  </a:r>
                </a:p>
              </p:txBody>
            </p:sp>
            <p:sp>
              <p:nvSpPr>
                <p:cNvPr id="13" name="CasellaDiTesto 12"/>
                <p:cNvSpPr txBox="1"/>
                <p:nvPr/>
              </p:nvSpPr>
              <p:spPr>
                <a:xfrm>
                  <a:off x="4699474" y="7170134"/>
                  <a:ext cx="1811661" cy="4718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defTabSz="1439898"/>
                  <a:r>
                    <a:rPr lang="it-IT" sz="2164" b="1" dirty="0">
                      <a:solidFill>
                        <a:prstClr val="black"/>
                      </a:solidFill>
                    </a:rPr>
                    <a:t>MONTHS</a:t>
                  </a:r>
                </a:p>
              </p:txBody>
            </p:sp>
            <p:sp>
              <p:nvSpPr>
                <p:cNvPr id="14" name="CasellaDiTesto 13"/>
                <p:cNvSpPr txBox="1"/>
                <p:nvPr/>
              </p:nvSpPr>
              <p:spPr>
                <a:xfrm>
                  <a:off x="700300" y="3778448"/>
                  <a:ext cx="1115623" cy="595009"/>
                </a:xfrm>
                <a:prstGeom prst="rect">
                  <a:avLst/>
                </a:prstGeom>
                <a:noFill/>
                <a:scene3d>
                  <a:camera prst="orthographicFront">
                    <a:rot lat="0" lon="0" rev="5400000"/>
                  </a:camera>
                  <a:lightRig rig="threePt" dir="t"/>
                </a:scene3d>
              </p:spPr>
              <p:txBody>
                <a:bodyPr wrap="square" rtlCol="0">
                  <a:spAutoFit/>
                </a:bodyPr>
                <a:lstStyle/>
                <a:p>
                  <a:pPr defTabSz="1439898"/>
                  <a:r>
                    <a:rPr lang="it-IT" sz="2886" b="1" dirty="0">
                      <a:solidFill>
                        <a:prstClr val="black"/>
                      </a:solidFill>
                    </a:rPr>
                    <a:t>OS%</a:t>
                  </a:r>
                </a:p>
              </p:txBody>
            </p:sp>
          </p:grpSp>
        </p:grpSp>
        <p:sp>
          <p:nvSpPr>
            <p:cNvPr id="23" name="CasellaDiTesto 22"/>
            <p:cNvSpPr txBox="1"/>
            <p:nvPr/>
          </p:nvSpPr>
          <p:spPr>
            <a:xfrm>
              <a:off x="5971598" y="4493725"/>
              <a:ext cx="407998" cy="2550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defTabSz="1439898"/>
              <a:r>
                <a:rPr lang="it-IT" sz="1683" b="1" dirty="0">
                  <a:solidFill>
                    <a:prstClr val="black"/>
                  </a:solidFill>
                </a:rPr>
                <a:t>130</a:t>
              </a:r>
            </a:p>
          </p:txBody>
        </p:sp>
        <p:sp>
          <p:nvSpPr>
            <p:cNvPr id="24" name="CasellaDiTesto 23"/>
            <p:cNvSpPr txBox="1"/>
            <p:nvPr/>
          </p:nvSpPr>
          <p:spPr>
            <a:xfrm>
              <a:off x="5244927" y="4493497"/>
              <a:ext cx="407998" cy="2550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defTabSz="1439898"/>
              <a:r>
                <a:rPr lang="it-IT" sz="1683" b="1" dirty="0">
                  <a:solidFill>
                    <a:prstClr val="black"/>
                  </a:solidFill>
                </a:rPr>
                <a:t>100</a:t>
              </a:r>
            </a:p>
          </p:txBody>
        </p:sp>
        <p:sp>
          <p:nvSpPr>
            <p:cNvPr id="25" name="CasellaDiTesto 24"/>
            <p:cNvSpPr txBox="1"/>
            <p:nvPr/>
          </p:nvSpPr>
          <p:spPr>
            <a:xfrm>
              <a:off x="4518256" y="4491045"/>
              <a:ext cx="407998" cy="2550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defTabSz="1439898"/>
              <a:r>
                <a:rPr lang="it-IT" sz="1683" b="1" dirty="0">
                  <a:solidFill>
                    <a:prstClr val="black"/>
                  </a:solidFill>
                </a:rPr>
                <a:t>70</a:t>
              </a:r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3791585" y="4491043"/>
              <a:ext cx="407998" cy="2550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defTabSz="1439898"/>
              <a:r>
                <a:rPr lang="it-IT" sz="1683" b="1" dirty="0">
                  <a:solidFill>
                    <a:prstClr val="black"/>
                  </a:solidFill>
                </a:rPr>
                <a:t>40</a:t>
              </a:r>
            </a:p>
          </p:txBody>
        </p:sp>
        <p:sp>
          <p:nvSpPr>
            <p:cNvPr id="27" name="CasellaDiTesto 26"/>
            <p:cNvSpPr txBox="1"/>
            <p:nvPr/>
          </p:nvSpPr>
          <p:spPr>
            <a:xfrm>
              <a:off x="3013103" y="4488817"/>
              <a:ext cx="407998" cy="2550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defTabSz="1439898"/>
              <a:r>
                <a:rPr lang="it-IT" sz="1683" b="1" dirty="0">
                  <a:solidFill>
                    <a:prstClr val="black"/>
                  </a:solidFill>
                </a:rPr>
                <a:t>10</a:t>
              </a:r>
            </a:p>
          </p:txBody>
        </p:sp>
      </p:grpSp>
      <p:sp>
        <p:nvSpPr>
          <p:cNvPr id="29" name="CasellaDiTesto 28"/>
          <p:cNvSpPr txBox="1"/>
          <p:nvPr/>
        </p:nvSpPr>
        <p:spPr>
          <a:xfrm>
            <a:off x="1998481" y="4238271"/>
            <a:ext cx="2216071" cy="388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439898"/>
            <a:r>
              <a:rPr lang="it-IT" sz="1924" b="1" dirty="0">
                <a:solidFill>
                  <a:prstClr val="black"/>
                </a:solidFill>
              </a:rPr>
              <a:t>Log-</a:t>
            </a:r>
            <a:r>
              <a:rPr lang="it-IT" sz="1924" b="1" dirty="0" err="1">
                <a:solidFill>
                  <a:prstClr val="black"/>
                </a:solidFill>
              </a:rPr>
              <a:t>rank</a:t>
            </a:r>
            <a:r>
              <a:rPr lang="it-IT" sz="1924" b="1" dirty="0">
                <a:solidFill>
                  <a:prstClr val="black"/>
                </a:solidFill>
              </a:rPr>
              <a:t> p=0.798</a:t>
            </a:r>
          </a:p>
        </p:txBody>
      </p:sp>
      <p:sp>
        <p:nvSpPr>
          <p:cNvPr id="32" name="CasellaDiTesto 31"/>
          <p:cNvSpPr txBox="1"/>
          <p:nvPr/>
        </p:nvSpPr>
        <p:spPr>
          <a:xfrm>
            <a:off x="7806850" y="2136638"/>
            <a:ext cx="22451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439898"/>
            <a:r>
              <a:rPr lang="it-IT" b="1" dirty="0">
                <a:solidFill>
                  <a:prstClr val="black"/>
                </a:solidFill>
              </a:rPr>
              <a:t>PDL1 ≤ 5%</a:t>
            </a:r>
          </a:p>
        </p:txBody>
      </p:sp>
      <p:sp>
        <p:nvSpPr>
          <p:cNvPr id="33" name="CasellaDiTesto 32"/>
          <p:cNvSpPr txBox="1"/>
          <p:nvPr/>
        </p:nvSpPr>
        <p:spPr>
          <a:xfrm>
            <a:off x="7806850" y="2422454"/>
            <a:ext cx="22451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439898"/>
            <a:r>
              <a:rPr lang="it-IT" b="1" dirty="0">
                <a:solidFill>
                  <a:prstClr val="black"/>
                </a:solidFill>
              </a:rPr>
              <a:t>PDL1 &gt; 5%</a:t>
            </a:r>
          </a:p>
        </p:txBody>
      </p:sp>
      <p:pic>
        <p:nvPicPr>
          <p:cNvPr id="34" name="Picture 5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224" t="17012" r="21015" b="77339"/>
          <a:stretch/>
        </p:blipFill>
        <p:spPr bwMode="auto">
          <a:xfrm>
            <a:off x="7169692" y="2177347"/>
            <a:ext cx="590795" cy="7110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CasellaDiTesto 1"/>
          <p:cNvSpPr txBox="1"/>
          <p:nvPr/>
        </p:nvSpPr>
        <p:spPr>
          <a:xfrm>
            <a:off x="573163" y="1392452"/>
            <a:ext cx="9050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b="1" dirty="0"/>
              <a:t>2A</a:t>
            </a:r>
          </a:p>
        </p:txBody>
      </p:sp>
      <p:grpSp>
        <p:nvGrpSpPr>
          <p:cNvPr id="30" name="Gruppo 29"/>
          <p:cNvGrpSpPr/>
          <p:nvPr/>
        </p:nvGrpSpPr>
        <p:grpSpPr>
          <a:xfrm>
            <a:off x="223010" y="7453027"/>
            <a:ext cx="7444807" cy="3265693"/>
            <a:chOff x="-607217" y="1842773"/>
            <a:chExt cx="8531227" cy="7250382"/>
          </a:xfrm>
        </p:grpSpPr>
        <p:pic>
          <p:nvPicPr>
            <p:cNvPr id="31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722" t="12942" r="26262" b="11642"/>
            <a:stretch/>
          </p:blipFill>
          <p:spPr bwMode="auto">
            <a:xfrm>
              <a:off x="901927" y="1842773"/>
              <a:ext cx="6847193" cy="63645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5" name="CasellaDiTesto 34"/>
            <p:cNvSpPr txBox="1"/>
            <p:nvPr/>
          </p:nvSpPr>
          <p:spPr>
            <a:xfrm>
              <a:off x="484485" y="7682707"/>
              <a:ext cx="432928" cy="35131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defTabSz="1439898"/>
              <a:r>
                <a:rPr lang="it-IT" sz="1683" b="1" dirty="0">
                  <a:solidFill>
                    <a:prstClr val="black"/>
                  </a:solidFill>
                </a:rPr>
                <a:t>0</a:t>
              </a:r>
            </a:p>
          </p:txBody>
        </p:sp>
        <p:sp>
          <p:nvSpPr>
            <p:cNvPr id="36" name="CasellaDiTesto 35"/>
            <p:cNvSpPr txBox="1"/>
            <p:nvPr/>
          </p:nvSpPr>
          <p:spPr>
            <a:xfrm>
              <a:off x="299974" y="6515929"/>
              <a:ext cx="617436" cy="35131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defTabSz="1439898"/>
              <a:r>
                <a:rPr lang="it-IT" sz="1683" b="1" dirty="0">
                  <a:solidFill>
                    <a:prstClr val="black"/>
                  </a:solidFill>
                </a:rPr>
                <a:t>20</a:t>
              </a:r>
            </a:p>
          </p:txBody>
        </p:sp>
        <p:sp>
          <p:nvSpPr>
            <p:cNvPr id="37" name="CasellaDiTesto 36"/>
            <p:cNvSpPr txBox="1"/>
            <p:nvPr/>
          </p:nvSpPr>
          <p:spPr>
            <a:xfrm>
              <a:off x="299974" y="5345187"/>
              <a:ext cx="617436" cy="35131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defTabSz="1439898"/>
              <a:r>
                <a:rPr lang="it-IT" sz="1683" b="1" dirty="0">
                  <a:solidFill>
                    <a:prstClr val="black"/>
                  </a:solidFill>
                </a:rPr>
                <a:t>40</a:t>
              </a:r>
            </a:p>
          </p:txBody>
        </p:sp>
        <p:sp>
          <p:nvSpPr>
            <p:cNvPr id="38" name="CasellaDiTesto 37"/>
            <p:cNvSpPr txBox="1"/>
            <p:nvPr/>
          </p:nvSpPr>
          <p:spPr>
            <a:xfrm>
              <a:off x="299974" y="4210196"/>
              <a:ext cx="617436" cy="35131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defTabSz="1439898"/>
              <a:r>
                <a:rPr lang="it-IT" sz="1683" b="1" dirty="0">
                  <a:solidFill>
                    <a:prstClr val="black"/>
                  </a:solidFill>
                </a:rPr>
                <a:t>60</a:t>
              </a:r>
            </a:p>
          </p:txBody>
        </p:sp>
        <p:sp>
          <p:nvSpPr>
            <p:cNvPr id="39" name="CasellaDiTesto 38"/>
            <p:cNvSpPr txBox="1"/>
            <p:nvPr/>
          </p:nvSpPr>
          <p:spPr>
            <a:xfrm>
              <a:off x="299974" y="3065827"/>
              <a:ext cx="617436" cy="35131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defTabSz="1439898"/>
              <a:r>
                <a:rPr lang="it-IT" sz="1683" b="1" dirty="0">
                  <a:solidFill>
                    <a:prstClr val="black"/>
                  </a:solidFill>
                </a:rPr>
                <a:t>80</a:t>
              </a:r>
            </a:p>
          </p:txBody>
        </p:sp>
        <p:sp>
          <p:nvSpPr>
            <p:cNvPr id="40" name="CasellaDiTesto 39"/>
            <p:cNvSpPr txBox="1"/>
            <p:nvPr/>
          </p:nvSpPr>
          <p:spPr>
            <a:xfrm>
              <a:off x="170764" y="1892094"/>
              <a:ext cx="749602" cy="35131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defTabSz="1439898"/>
              <a:r>
                <a:rPr lang="it-IT" sz="1683" b="1" dirty="0">
                  <a:solidFill>
                    <a:prstClr val="black"/>
                  </a:solidFill>
                </a:rPr>
                <a:t>100</a:t>
              </a:r>
            </a:p>
          </p:txBody>
        </p:sp>
        <p:sp>
          <p:nvSpPr>
            <p:cNvPr id="41" name="CasellaDiTesto 40"/>
            <p:cNvSpPr txBox="1"/>
            <p:nvPr/>
          </p:nvSpPr>
          <p:spPr>
            <a:xfrm>
              <a:off x="7174408" y="8240698"/>
              <a:ext cx="749602" cy="35131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defTabSz="1439898"/>
              <a:r>
                <a:rPr lang="it-IT" sz="1683" b="1" dirty="0">
                  <a:solidFill>
                    <a:prstClr val="black"/>
                  </a:solidFill>
                </a:rPr>
                <a:t>130</a:t>
              </a:r>
            </a:p>
          </p:txBody>
        </p:sp>
        <p:sp>
          <p:nvSpPr>
            <p:cNvPr id="42" name="CasellaDiTesto 41"/>
            <p:cNvSpPr txBox="1"/>
            <p:nvPr/>
          </p:nvSpPr>
          <p:spPr>
            <a:xfrm>
              <a:off x="5839318" y="8240279"/>
              <a:ext cx="749602" cy="35131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defTabSz="1439898"/>
              <a:r>
                <a:rPr lang="it-IT" sz="1683" b="1" dirty="0">
                  <a:solidFill>
                    <a:prstClr val="black"/>
                  </a:solidFill>
                </a:rPr>
                <a:t>100</a:t>
              </a:r>
            </a:p>
          </p:txBody>
        </p:sp>
        <p:sp>
          <p:nvSpPr>
            <p:cNvPr id="43" name="CasellaDiTesto 42"/>
            <p:cNvSpPr txBox="1"/>
            <p:nvPr/>
          </p:nvSpPr>
          <p:spPr>
            <a:xfrm>
              <a:off x="4504229" y="8235772"/>
              <a:ext cx="749602" cy="35131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defTabSz="1439898"/>
              <a:r>
                <a:rPr lang="it-IT" sz="1683" b="1" dirty="0">
                  <a:solidFill>
                    <a:prstClr val="black"/>
                  </a:solidFill>
                </a:rPr>
                <a:t>70</a:t>
              </a:r>
            </a:p>
          </p:txBody>
        </p:sp>
        <p:sp>
          <p:nvSpPr>
            <p:cNvPr id="44" name="CasellaDiTesto 43"/>
            <p:cNvSpPr txBox="1"/>
            <p:nvPr/>
          </p:nvSpPr>
          <p:spPr>
            <a:xfrm>
              <a:off x="3169139" y="8235770"/>
              <a:ext cx="749602" cy="35131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defTabSz="1439898"/>
              <a:r>
                <a:rPr lang="it-IT" sz="1683" b="1" dirty="0">
                  <a:solidFill>
                    <a:prstClr val="black"/>
                  </a:solidFill>
                </a:rPr>
                <a:t>40</a:t>
              </a:r>
            </a:p>
          </p:txBody>
        </p:sp>
        <p:sp>
          <p:nvSpPr>
            <p:cNvPr id="45" name="CasellaDiTesto 44"/>
            <p:cNvSpPr txBox="1"/>
            <p:nvPr/>
          </p:nvSpPr>
          <p:spPr>
            <a:xfrm>
              <a:off x="1738858" y="8231682"/>
              <a:ext cx="749602" cy="35131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defTabSz="1439898"/>
              <a:r>
                <a:rPr lang="it-IT" sz="1683" b="1" dirty="0">
                  <a:solidFill>
                    <a:prstClr val="black"/>
                  </a:solidFill>
                </a:rPr>
                <a:t>10</a:t>
              </a:r>
            </a:p>
          </p:txBody>
        </p:sp>
        <p:sp>
          <p:nvSpPr>
            <p:cNvPr id="46" name="CasellaDiTesto 45"/>
            <p:cNvSpPr txBox="1"/>
            <p:nvPr/>
          </p:nvSpPr>
          <p:spPr>
            <a:xfrm>
              <a:off x="4201360" y="8667782"/>
              <a:ext cx="1472703" cy="4253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1439898"/>
              <a:r>
                <a:rPr lang="it-IT" sz="2164" b="1" dirty="0">
                  <a:solidFill>
                    <a:prstClr val="black"/>
                  </a:solidFill>
                </a:rPr>
                <a:t>MONTHS</a:t>
              </a:r>
            </a:p>
          </p:txBody>
        </p:sp>
        <p:sp>
          <p:nvSpPr>
            <p:cNvPr id="47" name="CasellaDiTesto 46"/>
            <p:cNvSpPr txBox="1"/>
            <p:nvPr/>
          </p:nvSpPr>
          <p:spPr>
            <a:xfrm>
              <a:off x="-607217" y="4589639"/>
              <a:ext cx="1341417" cy="536429"/>
            </a:xfrm>
            <a:prstGeom prst="rect">
              <a:avLst/>
            </a:prstGeom>
            <a:noFill/>
            <a:scene3d>
              <a:camera prst="orthographicFront">
                <a:rot lat="0" lon="0" rev="5400000"/>
              </a:camera>
              <a:lightRig rig="threePt" dir="t"/>
            </a:scene3d>
          </p:spPr>
          <p:txBody>
            <a:bodyPr wrap="square" rtlCol="0">
              <a:spAutoFit/>
            </a:bodyPr>
            <a:lstStyle/>
            <a:p>
              <a:pPr defTabSz="1439898"/>
              <a:r>
                <a:rPr lang="it-IT" sz="2886" b="1" dirty="0">
                  <a:solidFill>
                    <a:prstClr val="black"/>
                  </a:solidFill>
                </a:rPr>
                <a:t>OS%</a:t>
              </a:r>
            </a:p>
          </p:txBody>
        </p:sp>
        <p:sp>
          <p:nvSpPr>
            <p:cNvPr id="48" name="CasellaDiTesto 47"/>
            <p:cNvSpPr txBox="1"/>
            <p:nvPr/>
          </p:nvSpPr>
          <p:spPr>
            <a:xfrm>
              <a:off x="1223446" y="7294267"/>
              <a:ext cx="2216071" cy="3884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1439898"/>
              <a:r>
                <a:rPr lang="it-IT" sz="1924" b="1" dirty="0">
                  <a:solidFill>
                    <a:prstClr val="black"/>
                  </a:solidFill>
                </a:rPr>
                <a:t>Log-</a:t>
              </a:r>
              <a:r>
                <a:rPr lang="it-IT" sz="1924" b="1" dirty="0" err="1">
                  <a:solidFill>
                    <a:prstClr val="black"/>
                  </a:solidFill>
                </a:rPr>
                <a:t>rank</a:t>
              </a:r>
              <a:r>
                <a:rPr lang="it-IT" sz="1924" b="1" dirty="0">
                  <a:solidFill>
                    <a:prstClr val="black"/>
                  </a:solidFill>
                </a:rPr>
                <a:t> p=0.936</a:t>
              </a:r>
            </a:p>
          </p:txBody>
        </p:sp>
      </p:grpSp>
      <p:sp>
        <p:nvSpPr>
          <p:cNvPr id="49" name="CasellaDiTesto 48"/>
          <p:cNvSpPr txBox="1"/>
          <p:nvPr/>
        </p:nvSpPr>
        <p:spPr>
          <a:xfrm>
            <a:off x="695772" y="7028511"/>
            <a:ext cx="9050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b="1" dirty="0" smtClean="0"/>
              <a:t>2B</a:t>
            </a:r>
            <a:endParaRPr lang="it-IT" sz="2000" b="1" dirty="0"/>
          </a:p>
        </p:txBody>
      </p:sp>
      <p:graphicFrame>
        <p:nvGraphicFramePr>
          <p:cNvPr id="50" name="Tabella 4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3109285"/>
              </p:ext>
            </p:extLst>
          </p:nvPr>
        </p:nvGraphicFramePr>
        <p:xfrm>
          <a:off x="239972" y="11094783"/>
          <a:ext cx="8466451" cy="115524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2607321"/>
                <a:gridCol w="938690"/>
                <a:gridCol w="2889417"/>
                <a:gridCol w="2031023"/>
              </a:tblGrid>
              <a:tr h="382541">
                <a:tc>
                  <a:txBody>
                    <a:bodyPr/>
                    <a:lstStyle/>
                    <a:p>
                      <a:pPr algn="ctr"/>
                      <a:r>
                        <a:rPr lang="it-IT" sz="1700" dirty="0" smtClean="0"/>
                        <a:t>PDL1 </a:t>
                      </a:r>
                      <a:r>
                        <a:rPr lang="it-IT" sz="1700" dirty="0" err="1" smtClean="0"/>
                        <a:t>cut</a:t>
                      </a:r>
                      <a:r>
                        <a:rPr lang="it-IT" sz="1700" dirty="0" smtClean="0"/>
                        <a:t>-off %</a:t>
                      </a:r>
                      <a:endParaRPr lang="it-IT" sz="1700" b="1" dirty="0">
                        <a:solidFill>
                          <a:schemeClr val="tx1"/>
                        </a:solidFill>
                      </a:endParaRPr>
                    </a:p>
                  </a:txBody>
                  <a:tcPr marL="126000" marR="126000" marT="63000" marB="6300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700" dirty="0" smtClean="0"/>
                        <a:t>n</a:t>
                      </a:r>
                      <a:endParaRPr lang="it-IT" sz="1700" b="1" dirty="0">
                        <a:solidFill>
                          <a:schemeClr val="tx1"/>
                        </a:solidFill>
                      </a:endParaRPr>
                    </a:p>
                  </a:txBody>
                  <a:tcPr marL="126000" marR="126000" marT="63000" marB="63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700" dirty="0" err="1" smtClean="0"/>
                        <a:t>Median</a:t>
                      </a:r>
                      <a:r>
                        <a:rPr lang="it-IT" sz="1700" dirty="0" smtClean="0"/>
                        <a:t> OS</a:t>
                      </a:r>
                      <a:endParaRPr lang="it-IT" sz="1700" b="1" dirty="0">
                        <a:solidFill>
                          <a:schemeClr val="tx1"/>
                        </a:solidFill>
                      </a:endParaRPr>
                    </a:p>
                  </a:txBody>
                  <a:tcPr marL="126000" marR="126000" marT="63000" marB="63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700" dirty="0" smtClean="0"/>
                        <a:t>95% CI</a:t>
                      </a:r>
                      <a:endParaRPr lang="it-IT" sz="1700" b="1" dirty="0">
                        <a:solidFill>
                          <a:schemeClr val="tx1"/>
                        </a:solidFill>
                      </a:endParaRPr>
                    </a:p>
                  </a:txBody>
                  <a:tcPr marL="126000" marR="126000" marT="63000" marB="63000" anchor="ctr"/>
                </a:tc>
              </a:tr>
              <a:tr h="382541">
                <a:tc>
                  <a:txBody>
                    <a:bodyPr/>
                    <a:lstStyle/>
                    <a:p>
                      <a:pPr algn="ctr"/>
                      <a:r>
                        <a:rPr lang="it-IT" sz="1700" dirty="0" smtClean="0"/>
                        <a:t>≤ 5</a:t>
                      </a:r>
                      <a:endParaRPr lang="it-IT" sz="1700" b="1" dirty="0">
                        <a:solidFill>
                          <a:schemeClr val="tx1"/>
                        </a:solidFill>
                      </a:endParaRPr>
                    </a:p>
                  </a:txBody>
                  <a:tcPr marL="126000" marR="126000" marT="63000" marB="6300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700" dirty="0" smtClean="0"/>
                        <a:t>9</a:t>
                      </a:r>
                      <a:endParaRPr lang="it-IT" sz="1700" dirty="0"/>
                    </a:p>
                  </a:txBody>
                  <a:tcPr marL="126000" marR="126000" marT="63000" marB="63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700" dirty="0" smtClean="0"/>
                        <a:t>22,78 m</a:t>
                      </a:r>
                      <a:endParaRPr lang="it-IT" sz="1700" dirty="0"/>
                    </a:p>
                  </a:txBody>
                  <a:tcPr marL="126000" marR="126000" marT="63000" marB="63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700" dirty="0" smtClean="0"/>
                        <a:t>0,80-44,76</a:t>
                      </a:r>
                      <a:endParaRPr lang="it-IT" sz="1700" dirty="0"/>
                    </a:p>
                  </a:txBody>
                  <a:tcPr marL="126000" marR="126000" marT="63000" marB="63000" anchor="ctr"/>
                </a:tc>
              </a:tr>
              <a:tr h="38254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700" dirty="0" smtClean="0"/>
                        <a:t>&gt; 5</a:t>
                      </a:r>
                      <a:endParaRPr lang="it-IT" sz="1700" b="1" dirty="0" smtClean="0"/>
                    </a:p>
                  </a:txBody>
                  <a:tcPr marL="126000" marR="126000" marT="63000" marB="6300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700" dirty="0" smtClean="0"/>
                        <a:t>18</a:t>
                      </a:r>
                      <a:endParaRPr lang="it-IT" sz="1700" dirty="0"/>
                    </a:p>
                  </a:txBody>
                  <a:tcPr marL="126000" marR="126000" marT="63000" marB="6300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700" dirty="0" smtClean="0"/>
                        <a:t>13,15 m</a:t>
                      </a:r>
                      <a:endParaRPr lang="it-IT" sz="1700" dirty="0"/>
                    </a:p>
                  </a:txBody>
                  <a:tcPr marL="126000" marR="126000" marT="63000" marB="63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700" dirty="0" smtClean="0"/>
                        <a:t>0,71-25,59</a:t>
                      </a:r>
                      <a:endParaRPr lang="it-IT" sz="1700" dirty="0"/>
                    </a:p>
                  </a:txBody>
                  <a:tcPr marL="126000" marR="126000" marT="63000" marB="63000" anchor="ctr"/>
                </a:tc>
              </a:tr>
            </a:tbl>
          </a:graphicData>
        </a:graphic>
      </p:graphicFrame>
      <p:sp>
        <p:nvSpPr>
          <p:cNvPr id="51" name="CasellaDiTesto 50"/>
          <p:cNvSpPr txBox="1"/>
          <p:nvPr/>
        </p:nvSpPr>
        <p:spPr>
          <a:xfrm>
            <a:off x="7819120" y="7730940"/>
            <a:ext cx="22451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439898"/>
            <a:r>
              <a:rPr lang="it-IT" b="1" dirty="0">
                <a:solidFill>
                  <a:prstClr val="black"/>
                </a:solidFill>
              </a:rPr>
              <a:t>PDL1 ≤ 5%</a:t>
            </a:r>
          </a:p>
        </p:txBody>
      </p:sp>
      <p:sp>
        <p:nvSpPr>
          <p:cNvPr id="52" name="CasellaDiTesto 51"/>
          <p:cNvSpPr txBox="1"/>
          <p:nvPr/>
        </p:nvSpPr>
        <p:spPr>
          <a:xfrm>
            <a:off x="7819120" y="8016756"/>
            <a:ext cx="22451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439898"/>
            <a:r>
              <a:rPr lang="it-IT" b="1" dirty="0">
                <a:solidFill>
                  <a:prstClr val="black"/>
                </a:solidFill>
              </a:rPr>
              <a:t>PDL1 &gt; 5%</a:t>
            </a:r>
          </a:p>
        </p:txBody>
      </p:sp>
      <p:pic>
        <p:nvPicPr>
          <p:cNvPr id="53" name="Picture 5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224" t="17012" r="21015" b="77339"/>
          <a:stretch/>
        </p:blipFill>
        <p:spPr bwMode="auto">
          <a:xfrm>
            <a:off x="7181962" y="7771649"/>
            <a:ext cx="590795" cy="7110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988732980"/>
      </p:ext>
    </p:extLst>
  </p:cSld>
  <p:clrMapOvr>
    <a:masterClrMapping/>
  </p:clrMapOvr>
</p:sld>
</file>

<file path=ppt/theme/theme1.xml><?xml version="1.0" encoding="utf-8"?>
<a:theme xmlns:a="http://schemas.openxmlformats.org/drawingml/2006/main" name="1_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14</Words>
  <Application>Microsoft Office PowerPoint</Application>
  <PresentationFormat>Personnalisé</PresentationFormat>
  <Paragraphs>5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1_Tema di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ia Vittoria Dieci</dc:creator>
  <cp:lastModifiedBy>maria vittoria dieci</cp:lastModifiedBy>
  <cp:revision>3</cp:revision>
  <dcterms:created xsi:type="dcterms:W3CDTF">2017-11-10T16:04:37Z</dcterms:created>
  <dcterms:modified xsi:type="dcterms:W3CDTF">2017-12-02T10:49:22Z</dcterms:modified>
</cp:coreProperties>
</file>